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46CBF-CB2A-4683-848A-DE5159ED93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25F62-FF57-4D03-8587-646D4A6AB5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A647D-4261-48BF-8CB0-6448FE3EF8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9685D2-68BE-4029-988B-0D95F02598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65B80B-C278-4BBE-950E-1678717FEE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07A04-12A0-4811-BB7F-6B26ECDDF1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788A65-8943-40EF-ADF9-BCA9F29EBC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7CAA8-11B9-4D8E-91AC-7C2E6EF115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20032-5D8C-4F0A-8F4D-DCB3F1EF93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959E4-0197-4A6B-B45A-3EB6281CA9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8525A-57F5-4CAA-ADC4-8AD22369FB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8DC43-E607-493D-9270-F2A51DE1FB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6FCDEF-4773-44EB-8946-93D15DA9631F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Users\user\Desktop\Microbiology Open\Supplementary data\Fig S1.tif"/>
          <p:cNvPicPr/>
          <p:nvPr/>
        </p:nvPicPr>
        <p:blipFill>
          <a:blip r:embed="rId1"/>
          <a:stretch/>
        </p:blipFill>
        <p:spPr>
          <a:xfrm>
            <a:off x="1120680" y="252360"/>
            <a:ext cx="6858000" cy="430848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285840" y="4699080"/>
            <a:ext cx="86439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chematic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ocus and construc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bW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oexist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smegmat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ome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Diagram depicts allelic replacement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ith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ssette retaining a small portion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t both 5’ and 3’ ends. Probe 1 and Probe 2 positions are indicated by bar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PCR analysi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. Primers corresponding to left over nucleotide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at both ends amplified a 0.75 kb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F from WT (lane 1) and 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38 kb </a:t>
            </a:r>
            <a:r>
              <a:rPr b="0" i="1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yg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assette from Δ</a:t>
            </a:r>
            <a:r>
              <a:rPr b="0" i="1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lane 2)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Southern hybridization of SmaI digested genomic DNA from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smegmat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T (lane 3) and Δ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s (lanes 1 and 2). (i) Probe 1 hybridized to 2.2 kb and 1.6 kb fragments in mutants (lanes 1 and 2) and WT (lane 3), respectively. (ii) Blot was reprobed with Probe 2, which hybridized to 2.2 kb fragment in mutants (lanes 1 and 2) but failed to hybridize in wild type strain (lane 3) owing to absence of hygromycin.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Carotenoid pigments present in WT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. smegmati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i) are distinctly absent in Δ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 (ii) coloni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08T06:40:35Z</dcterms:created>
  <dc:creator>user</dc:creator>
  <dc:description/>
  <dc:language>en-US</dc:language>
  <cp:lastModifiedBy>user</cp:lastModifiedBy>
  <dcterms:modified xsi:type="dcterms:W3CDTF">2015-08-08T06:54:09Z</dcterms:modified>
  <cp:revision>3</cp:revision>
  <dc:subject/>
  <dc:title>Slide 1</dc:title>
</cp:coreProperties>
</file>